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75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D641D7-B56F-4768-9BAA-A2E2B8E78AE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93DC4E9-9E7B-448A-BAE6-7EE8458E668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AA4559-9439-4635-9997-4AE3309697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0F4D0-CA48-4A97-A9FA-B5686EC94D0A}" type="datetimeFigureOut">
              <a:rPr lang="en-US" smtClean="0"/>
              <a:t>12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F44DD4-64DC-434B-BCE1-9977C221D8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C0CC4C-CEA6-4395-9647-6F8E5365A9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4097F-EF98-4AD2-B456-AD3370CDC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87812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302FAB-356F-408D-89DB-65F45BB871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2966003-524D-4BA7-A24C-2AC165A3E0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31E5EF-AB71-4A45-81FF-8C3F076102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0F4D0-CA48-4A97-A9FA-B5686EC94D0A}" type="datetimeFigureOut">
              <a:rPr lang="en-US" smtClean="0"/>
              <a:t>12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6C77BA-04D4-4544-B252-73132B3202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2BD8B9-3265-4BBE-9072-D741BB7090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4097F-EF98-4AD2-B456-AD3370CDC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00993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75470B3-AB7C-49B5-ACCF-1DDE8B2E22B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1C47F5F-2051-4800-B282-EFED5AE9F7F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66A555-B17B-42B1-8339-419AD5ACC0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0F4D0-CA48-4A97-A9FA-B5686EC94D0A}" type="datetimeFigureOut">
              <a:rPr lang="en-US" smtClean="0"/>
              <a:t>12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EDE9D0-47D0-4486-83B3-207A98701D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C726AB-F1BF-4045-B489-E6E94850FD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4097F-EF98-4AD2-B456-AD3370CDC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96889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F6CCB6-2509-455C-A068-937D835541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3C2F653-7FAB-46D3-BC91-FD80B14EAF7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D801B8-B113-4629-82B1-F9A96017C4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0F4D0-CA48-4A97-A9FA-B5686EC94D0A}" type="datetimeFigureOut">
              <a:rPr lang="en-US" smtClean="0"/>
              <a:t>12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2B4E02-EB2F-49DD-93C0-F31D45ED83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BBB7A6-CEB8-422A-89ED-108F890A6F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4097F-EF98-4AD2-B456-AD3370CDC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66233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C7BFD5-1282-402C-A47E-0F145CAA5E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D2999E-B4D5-4350-A80F-FAFB0FEDC1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3D8C39-ED9F-4D8B-8F41-E5FF6CF802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0F4D0-CA48-4A97-A9FA-B5686EC94D0A}" type="datetimeFigureOut">
              <a:rPr lang="en-US" smtClean="0"/>
              <a:t>12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5D9ED1-E7BF-4069-B9A0-05A0F6DBEF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A65E93-C044-4B9F-82B6-32E087BAD2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4097F-EF98-4AD2-B456-AD3370CDC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30659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E1D96C-692C-425E-AFA8-9536CD8B2A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E2676B-BF13-49BA-A0D6-44749294135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6E33F88-56CB-4E68-90F9-23CA2FD0C8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2659E7-B570-4BD2-9087-742240795B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0F4D0-CA48-4A97-A9FA-B5686EC94D0A}" type="datetimeFigureOut">
              <a:rPr lang="en-US" smtClean="0"/>
              <a:t>12/2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273B8B-F97F-4C67-9D93-D4257E256F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479EE8D-8CBA-4FD6-A8A9-513BF5452C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4097F-EF98-4AD2-B456-AD3370CDC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55017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B01B19-6DC4-4025-8005-75FEF31866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A1ED1C-86EA-4743-A411-F546E86635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9364ED2-B95E-43E3-8970-F949222ED3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B785C5A-FA0C-4E5F-BA43-DB7F7BBE9A6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CB4F8C7-E711-46E8-BC47-19BC3EE5AB7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32CC7CA-9471-4026-8F15-AD6DF4B886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0F4D0-CA48-4A97-A9FA-B5686EC94D0A}" type="datetimeFigureOut">
              <a:rPr lang="en-US" smtClean="0"/>
              <a:t>12/20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0159B6D-63FD-4A4B-A09A-70E9D279EF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6B807EA-9755-4A2A-9A27-8988740DFB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4097F-EF98-4AD2-B456-AD3370CDC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1494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BFC3A8-5BD6-4D8D-A21C-96B5CF4739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74262C7-A554-43AC-8BDD-993A87A631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0F4D0-CA48-4A97-A9FA-B5686EC94D0A}" type="datetimeFigureOut">
              <a:rPr lang="en-US" smtClean="0"/>
              <a:t>12/20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2D3DC39-F7F8-46E2-A3D2-F3FE47D989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E0AE0AB-DF23-425C-97DD-A8859BE74B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4097F-EF98-4AD2-B456-AD3370CDC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69416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595D876-D4DF-4912-A18D-C0C59012A1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0F4D0-CA48-4A97-A9FA-B5686EC94D0A}" type="datetimeFigureOut">
              <a:rPr lang="en-US" smtClean="0"/>
              <a:t>12/20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D48CF1F-95CE-4A10-BBEB-45369D7F3A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E0CDD00-B786-4EF5-81B0-58AF29F268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4097F-EF98-4AD2-B456-AD3370CDC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13079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59CF01-7858-45E7-833F-EA2E5E1B8A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D030D5-D20E-4AD7-A737-9352A600E82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5215A3D-4FC6-46B4-9A0E-7D38EBD0FC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006D8AD-9F09-4C40-ACCF-3F88635C99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0F4D0-CA48-4A97-A9FA-B5686EC94D0A}" type="datetimeFigureOut">
              <a:rPr lang="en-US" smtClean="0"/>
              <a:t>12/2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4BCAF1-F6F7-4DA7-B52D-880261F993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5A2CA9F-D785-4271-AC5D-30A3F01D06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4097F-EF98-4AD2-B456-AD3370CDC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046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B0547-8872-4A8B-B214-4FEF72D907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88FF778-43C9-4A0A-AAA7-7885ACD2AAC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6F59E1E-7B6E-4D12-9390-D9EF434D13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262D454-090D-48CC-AB32-34D240B034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0F4D0-CA48-4A97-A9FA-B5686EC94D0A}" type="datetimeFigureOut">
              <a:rPr lang="en-US" smtClean="0"/>
              <a:t>12/2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096C14-BBAE-406B-87D2-CEE6742E83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C408ACD-99DE-44E6-8320-25E9EE9B4D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4097F-EF98-4AD2-B456-AD3370CDC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08191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A82D60D-2CE5-4D55-B9EA-C5CF442D49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EB62C9-CAE7-401D-9EE9-6A3323AD4B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C72402-278A-4B1B-A8DE-A142A738D7C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10F4D0-CA48-4A97-A9FA-B5686EC94D0A}" type="datetimeFigureOut">
              <a:rPr lang="en-US" smtClean="0"/>
              <a:t>12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D3A271-CCF5-4631-B76C-D17BFA63D9F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291E11-F56C-4509-B9BD-03AAED3F4A0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54097F-EF98-4AD2-B456-AD3370CDC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0023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ti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77540F2D-7F2A-4F49-BC67-5430C8A32DDB}"/>
              </a:ext>
            </a:extLst>
          </p:cNvPr>
          <p:cNvSpPr txBox="1"/>
          <p:nvPr/>
        </p:nvSpPr>
        <p:spPr>
          <a:xfrm>
            <a:off x="656938" y="317063"/>
            <a:ext cx="17899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. Figure 1. 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64AB9BB-8311-4A03-85B4-8EB765594668}"/>
              </a:ext>
            </a:extLst>
          </p:cNvPr>
          <p:cNvSpPr txBox="1"/>
          <p:nvPr/>
        </p:nvSpPr>
        <p:spPr>
          <a:xfrm>
            <a:off x="6818026" y="357035"/>
            <a:ext cx="17802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. Figure 1. 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50A47FB-BBB7-49F8-8D42-092C42EF2442}"/>
              </a:ext>
            </a:extLst>
          </p:cNvPr>
          <p:cNvSpPr txBox="1"/>
          <p:nvPr/>
        </p:nvSpPr>
        <p:spPr>
          <a:xfrm>
            <a:off x="629230" y="3745468"/>
            <a:ext cx="17722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. Figure 1. C</a:t>
            </a:r>
          </a:p>
        </p:txBody>
      </p:sp>
      <p:pic>
        <p:nvPicPr>
          <p:cNvPr id="11" name="Picture 10" descr="Chart, line chart&#10;&#10;Description automatically generated">
            <a:extLst>
              <a:ext uri="{FF2B5EF4-FFF2-40B4-BE49-F238E27FC236}">
                <a16:creationId xmlns:a16="http://schemas.microsoft.com/office/drawing/2014/main" id="{82F569FF-140F-41E3-BB5E-D89F347EF0C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3052" y="726367"/>
            <a:ext cx="4114800" cy="2743200"/>
          </a:xfrm>
          <a:prstGeom prst="rect">
            <a:avLst/>
          </a:prstGeom>
        </p:spPr>
      </p:pic>
      <p:pic>
        <p:nvPicPr>
          <p:cNvPr id="13" name="Picture 12" descr="Chart, line chart&#10;&#10;Description automatically generated">
            <a:extLst>
              <a:ext uri="{FF2B5EF4-FFF2-40B4-BE49-F238E27FC236}">
                <a16:creationId xmlns:a16="http://schemas.microsoft.com/office/drawing/2014/main" id="{5E245E27-514D-4DB5-87D3-A785CEE70EC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18026" y="726367"/>
            <a:ext cx="4114800" cy="2743200"/>
          </a:xfrm>
          <a:prstGeom prst="rect">
            <a:avLst/>
          </a:prstGeom>
        </p:spPr>
      </p:pic>
      <p:pic>
        <p:nvPicPr>
          <p:cNvPr id="15" name="Picture 14" descr="Chart, line chart&#10;&#10;Description automatically generated">
            <a:extLst>
              <a:ext uri="{FF2B5EF4-FFF2-40B4-BE49-F238E27FC236}">
                <a16:creationId xmlns:a16="http://schemas.microsoft.com/office/drawing/2014/main" id="{72C0680F-3FED-4201-896F-1A9B3052AFD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3052" y="4114800"/>
            <a:ext cx="4114800" cy="2743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24358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&#10;&#10;Description automatically generated">
            <a:extLst>
              <a:ext uri="{FF2B5EF4-FFF2-40B4-BE49-F238E27FC236}">
                <a16:creationId xmlns:a16="http://schemas.microsoft.com/office/drawing/2014/main" id="{B64E59A6-BD69-45FD-B78D-10A19A1BC13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6938" y="986866"/>
            <a:ext cx="4114800" cy="27432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3823ECB-7800-4205-A488-41D452C3A744}"/>
              </a:ext>
            </a:extLst>
          </p:cNvPr>
          <p:cNvSpPr txBox="1"/>
          <p:nvPr/>
        </p:nvSpPr>
        <p:spPr>
          <a:xfrm>
            <a:off x="656938" y="317063"/>
            <a:ext cx="17899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. Figure 2. 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42CB92C-329D-4DD1-AB40-CF1689D358DD}"/>
              </a:ext>
            </a:extLst>
          </p:cNvPr>
          <p:cNvSpPr txBox="1"/>
          <p:nvPr/>
        </p:nvSpPr>
        <p:spPr>
          <a:xfrm>
            <a:off x="6818026" y="357035"/>
            <a:ext cx="17802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. Figure 2. B</a:t>
            </a:r>
          </a:p>
        </p:txBody>
      </p:sp>
      <p:pic>
        <p:nvPicPr>
          <p:cNvPr id="7" name="Picture 6" descr="Chart&#10;&#10;Description automatically generated">
            <a:extLst>
              <a:ext uri="{FF2B5EF4-FFF2-40B4-BE49-F238E27FC236}">
                <a16:creationId xmlns:a16="http://schemas.microsoft.com/office/drawing/2014/main" id="{EC99225C-A5CC-4D7E-BB3B-ABCC63CB6F6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18026" y="986866"/>
            <a:ext cx="4114800" cy="2743200"/>
          </a:xfrm>
          <a:prstGeom prst="rect">
            <a:avLst/>
          </a:prstGeom>
        </p:spPr>
      </p:pic>
      <p:pic>
        <p:nvPicPr>
          <p:cNvPr id="9" name="Picture 8" descr="Chart&#10;&#10;Description automatically generated">
            <a:extLst>
              <a:ext uri="{FF2B5EF4-FFF2-40B4-BE49-F238E27FC236}">
                <a16:creationId xmlns:a16="http://schemas.microsoft.com/office/drawing/2014/main" id="{252CDD5F-0747-447C-9224-36B05DA38C6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6938" y="4114800"/>
            <a:ext cx="4114800" cy="27432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8048BD97-1BE0-4D35-82C5-D9B7D381DFA2}"/>
              </a:ext>
            </a:extLst>
          </p:cNvPr>
          <p:cNvSpPr txBox="1"/>
          <p:nvPr/>
        </p:nvSpPr>
        <p:spPr>
          <a:xfrm>
            <a:off x="629230" y="3745468"/>
            <a:ext cx="17722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. Figure 2. C</a:t>
            </a:r>
          </a:p>
        </p:txBody>
      </p:sp>
    </p:spTree>
    <p:extLst>
      <p:ext uri="{BB962C8B-B14F-4D97-AF65-F5344CB8AC3E}">
        <p14:creationId xmlns:p14="http://schemas.microsoft.com/office/powerpoint/2010/main" val="36642539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72C1147-E6C9-46D1-9B05-950A99087A0E}"/>
              </a:ext>
            </a:extLst>
          </p:cNvPr>
          <p:cNvSpPr txBox="1"/>
          <p:nvPr/>
        </p:nvSpPr>
        <p:spPr>
          <a:xfrm>
            <a:off x="0" y="267187"/>
            <a:ext cx="15366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. Figure 3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7D113F4-7778-4494-BEA9-55AC83AB7A1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36639" y="267187"/>
            <a:ext cx="10105697" cy="64741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122756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Chart, radar chart&#10;&#10;Description automatically generated">
            <a:extLst>
              <a:ext uri="{FF2B5EF4-FFF2-40B4-BE49-F238E27FC236}">
                <a16:creationId xmlns:a16="http://schemas.microsoft.com/office/drawing/2014/main" id="{569FDE52-EF23-4EE6-9BFF-9338A79BBC2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1565" y="49192"/>
            <a:ext cx="7906917" cy="6589098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B62F1CA-2956-48B5-9032-7298E4877F71}"/>
              </a:ext>
            </a:extLst>
          </p:cNvPr>
          <p:cNvSpPr txBox="1"/>
          <p:nvPr/>
        </p:nvSpPr>
        <p:spPr>
          <a:xfrm>
            <a:off x="0" y="267187"/>
            <a:ext cx="15366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. Figure 4</a:t>
            </a:r>
          </a:p>
        </p:txBody>
      </p:sp>
    </p:spTree>
    <p:extLst>
      <p:ext uri="{BB962C8B-B14F-4D97-AF65-F5344CB8AC3E}">
        <p14:creationId xmlns:p14="http://schemas.microsoft.com/office/powerpoint/2010/main" val="33527273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A picture containing antenna&#10;&#10;Description automatically generated">
            <a:extLst>
              <a:ext uri="{FF2B5EF4-FFF2-40B4-BE49-F238E27FC236}">
                <a16:creationId xmlns:a16="http://schemas.microsoft.com/office/drawing/2014/main" id="{1EC193CE-C4A7-4F9B-8F2E-E0B4B4578EE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9" t="738" b="544"/>
          <a:stretch/>
        </p:blipFill>
        <p:spPr>
          <a:xfrm>
            <a:off x="2581275" y="180975"/>
            <a:ext cx="6273358" cy="6229350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DB2077F-09DB-494E-A51B-AA38C2AED193}"/>
              </a:ext>
            </a:extLst>
          </p:cNvPr>
          <p:cNvSpPr txBox="1"/>
          <p:nvPr/>
        </p:nvSpPr>
        <p:spPr>
          <a:xfrm>
            <a:off x="0" y="267187"/>
            <a:ext cx="15366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. Figure 5</a:t>
            </a:r>
          </a:p>
        </p:txBody>
      </p:sp>
    </p:spTree>
    <p:extLst>
      <p:ext uri="{BB962C8B-B14F-4D97-AF65-F5344CB8AC3E}">
        <p14:creationId xmlns:p14="http://schemas.microsoft.com/office/powerpoint/2010/main" val="39523090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11</TotalTime>
  <Words>48</Words>
  <Application>Microsoft Office PowerPoint</Application>
  <PresentationFormat>Widescreen</PresentationFormat>
  <Paragraphs>9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, Song</dc:creator>
  <cp:lastModifiedBy>Li, Song</cp:lastModifiedBy>
  <cp:revision>22</cp:revision>
  <dcterms:created xsi:type="dcterms:W3CDTF">2021-04-28T18:59:05Z</dcterms:created>
  <dcterms:modified xsi:type="dcterms:W3CDTF">2021-12-20T08:58:32Z</dcterms:modified>
</cp:coreProperties>
</file>